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S45</a:t>
            </a:r>
            <a:r>
              <a:rPr lang="en-GB" sz="1600" dirty="0" smtClean="0"/>
              <a:t>: 3D model structure and validation of </a:t>
            </a:r>
            <a:r>
              <a:rPr lang="en-US" sz="1600" dirty="0" smtClean="0"/>
              <a:t>VEGFA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3v2a_A 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3v2a_A  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285720" y="142852"/>
            <a:ext cx="3500462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14942" y="71414"/>
            <a:ext cx="3643338" cy="3000396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6149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85720" y="3143248"/>
            <a:ext cx="3500462" cy="27622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214686"/>
            <a:ext cx="3643338" cy="29146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3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90</cp:revision>
  <dcterms:created xsi:type="dcterms:W3CDTF">2018-05-10T07:33:24Z</dcterms:created>
  <dcterms:modified xsi:type="dcterms:W3CDTF">2018-05-29T07:50:24Z</dcterms:modified>
</cp:coreProperties>
</file>